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80" r:id="rId2"/>
  </p:sldIdLst>
  <p:sldSz cx="7772400" cy="10058400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7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28" autoAdjust="0"/>
    <p:restoredTop sz="96429" autoAdjust="0"/>
  </p:normalViewPr>
  <p:slideViewPr>
    <p:cSldViewPr snapToGrid="0">
      <p:cViewPr varScale="1">
        <p:scale>
          <a:sx n="65" d="100"/>
          <a:sy n="65" d="100"/>
        </p:scale>
        <p:origin x="121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473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06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7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14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028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99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007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12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92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4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65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1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1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tiff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3935640" y="1725963"/>
            <a:ext cx="2605576" cy="450000"/>
            <a:chOff x="2455101" y="4597054"/>
            <a:chExt cx="2931092" cy="808273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68" t="42854" r="30156" b="43780"/>
            <a:stretch/>
          </p:blipFill>
          <p:spPr>
            <a:xfrm>
              <a:off x="2455101" y="4597054"/>
              <a:ext cx="2931092" cy="80827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68" t="42904" r="65431" b="43781"/>
            <a:stretch/>
          </p:blipFill>
          <p:spPr>
            <a:xfrm>
              <a:off x="2455662" y="4600118"/>
              <a:ext cx="249514" cy="805207"/>
            </a:xfrm>
            <a:prstGeom prst="rect">
              <a:avLst/>
            </a:prstGeom>
          </p:spPr>
        </p:pic>
      </p:grpSp>
      <p:sp>
        <p:nvSpPr>
          <p:cNvPr id="90" name="TextBox 88">
            <a:extLst>
              <a:ext uri="{FF2B5EF4-FFF2-40B4-BE49-F238E27FC236}">
                <a16:creationId xmlns:a16="http://schemas.microsoft.com/office/drawing/2014/main" id="{FAAFA852-C263-4C3A-B618-F5A88E9573AF}"/>
              </a:ext>
            </a:extLst>
          </p:cNvPr>
          <p:cNvSpPr txBox="1"/>
          <p:nvPr/>
        </p:nvSpPr>
        <p:spPr>
          <a:xfrm>
            <a:off x="687936" y="172022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683148" y="190261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683148" y="252408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638148" y="1507405"/>
            <a:ext cx="4165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8388FA38-17AA-427D-8195-9B6CE6C0057A}"/>
              </a:ext>
            </a:extLst>
          </p:cNvPr>
          <p:cNvCxnSpPr>
            <a:cxnSpLocks/>
          </p:cNvCxnSpPr>
          <p:nvPr/>
        </p:nvCxnSpPr>
        <p:spPr>
          <a:xfrm>
            <a:off x="923374" y="184618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925551" y="203641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925551" y="264180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1174419" y="1443192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1366867" y="1363867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8A67C46-6AFD-4122-B0C3-9A2C0A31E8C2}"/>
              </a:ext>
            </a:extLst>
          </p:cNvPr>
          <p:cNvSpPr txBox="1"/>
          <p:nvPr/>
        </p:nvSpPr>
        <p:spPr>
          <a:xfrm>
            <a:off x="1999823" y="714987"/>
            <a:ext cx="7531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7998B0A6-8B81-4190-AF33-FDF0FCFBC8E1}"/>
              </a:ext>
            </a:extLst>
          </p:cNvPr>
          <p:cNvSpPr txBox="1"/>
          <p:nvPr/>
        </p:nvSpPr>
        <p:spPr>
          <a:xfrm>
            <a:off x="1233897" y="106028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직선 연결선 102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1324012" y="1297135"/>
            <a:ext cx="446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" name="그림 103" descr="하얀색, 기기이(가) 표시된 사진&#10;&#10;자동 생성된 설명">
            <a:extLst>
              <a:ext uri="{FF2B5EF4-FFF2-40B4-BE49-F238E27FC236}">
                <a16:creationId xmlns:a16="http://schemas.microsoft.com/office/drawing/2014/main" id="{FC190D1D-4685-46E4-84EC-EE93EA37126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2" t="35023" r="12959" b="42506"/>
          <a:stretch/>
        </p:blipFill>
        <p:spPr>
          <a:xfrm>
            <a:off x="963128" y="2252784"/>
            <a:ext cx="2611574" cy="67196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id="{D210E6C5-6D1C-423A-B3EB-C4F637582700}"/>
              </a:ext>
            </a:extLst>
          </p:cNvPr>
          <p:cNvSpPr txBox="1"/>
          <p:nvPr/>
        </p:nvSpPr>
        <p:spPr>
          <a:xfrm>
            <a:off x="2926619" y="106555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E08010E2-12D6-4D21-B91B-61418FDCFF67}"/>
              </a:ext>
            </a:extLst>
          </p:cNvPr>
          <p:cNvCxnSpPr>
            <a:cxnSpLocks/>
          </p:cNvCxnSpPr>
          <p:nvPr/>
        </p:nvCxnSpPr>
        <p:spPr>
          <a:xfrm>
            <a:off x="3049502" y="1288345"/>
            <a:ext cx="480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2" name="그림 141" descr="기기, 하얀색, 실내, 백색가전제품이(가) 표시된 사진&#10;&#10;자동 생성된 설명">
            <a:extLst>
              <a:ext uri="{FF2B5EF4-FFF2-40B4-BE49-F238E27FC236}">
                <a16:creationId xmlns:a16="http://schemas.microsoft.com/office/drawing/2014/main" id="{B99C30D2-8152-45B6-8A65-17175325007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29" t="34014" r="13833" b="42707"/>
          <a:stretch/>
        </p:blipFill>
        <p:spPr>
          <a:xfrm>
            <a:off x="3934732" y="2254471"/>
            <a:ext cx="2607480" cy="6691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7" name="TextBox 88">
            <a:extLst>
              <a:ext uri="{FF2B5EF4-FFF2-40B4-BE49-F238E27FC236}">
                <a16:creationId xmlns:a16="http://schemas.microsoft.com/office/drawing/2014/main" id="{FAAFA852-C263-4C3A-B618-F5A88E9573AF}"/>
              </a:ext>
            </a:extLst>
          </p:cNvPr>
          <p:cNvSpPr txBox="1"/>
          <p:nvPr/>
        </p:nvSpPr>
        <p:spPr>
          <a:xfrm>
            <a:off x="3660591" y="172822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3658086" y="252408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3605984" y="1512007"/>
            <a:ext cx="4165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8388FA38-17AA-427D-8195-9B6CE6C0057A}"/>
              </a:ext>
            </a:extLst>
          </p:cNvPr>
          <p:cNvCxnSpPr>
            <a:cxnSpLocks/>
          </p:cNvCxnSpPr>
          <p:nvPr/>
        </p:nvCxnSpPr>
        <p:spPr>
          <a:xfrm>
            <a:off x="3897495" y="185319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3897506" y="264407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F893D8FC-90EC-4047-83FC-62438E66FC16}"/>
              </a:ext>
            </a:extLst>
          </p:cNvPr>
          <p:cNvSpPr txBox="1"/>
          <p:nvPr/>
        </p:nvSpPr>
        <p:spPr>
          <a:xfrm>
            <a:off x="4825406" y="713596"/>
            <a:ext cx="121217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352B69AA-EC80-43F1-996A-EE4A63876B7F}"/>
              </a:ext>
            </a:extLst>
          </p:cNvPr>
          <p:cNvSpPr txBox="1"/>
          <p:nvPr/>
        </p:nvSpPr>
        <p:spPr>
          <a:xfrm>
            <a:off x="6599630" y="4410047"/>
            <a:ext cx="87336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479086D6-7FFE-4CB3-9E5C-1B777BA463DA}"/>
              </a:ext>
            </a:extLst>
          </p:cNvPr>
          <p:cNvSpPr txBox="1"/>
          <p:nvPr/>
        </p:nvSpPr>
        <p:spPr>
          <a:xfrm>
            <a:off x="6599630" y="5182049"/>
            <a:ext cx="92944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D638AB02-11C0-4D31-8D59-65E3B70116F5}"/>
              </a:ext>
            </a:extLst>
          </p:cNvPr>
          <p:cNvSpPr txBox="1"/>
          <p:nvPr/>
        </p:nvSpPr>
        <p:spPr>
          <a:xfrm>
            <a:off x="6600856" y="1819596"/>
            <a:ext cx="87336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86289526-1175-43AF-8580-9AD2D37F6F14}"/>
              </a:ext>
            </a:extLst>
          </p:cNvPr>
          <p:cNvSpPr txBox="1"/>
          <p:nvPr/>
        </p:nvSpPr>
        <p:spPr>
          <a:xfrm>
            <a:off x="6600857" y="2502490"/>
            <a:ext cx="92944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692680" y="422536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692680" y="5099737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632225" y="4072710"/>
            <a:ext cx="431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4" name="직선 연결선 25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935205" y="4348475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직선 연결선 255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935205" y="523035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7" name="그림 256" descr="벽, 실내, 하얀색, 잭이(가) 표시된 사진&#10;&#10;자동 생성된 설명">
            <a:extLst>
              <a:ext uri="{FF2B5EF4-FFF2-40B4-BE49-F238E27FC236}">
                <a16:creationId xmlns:a16="http://schemas.microsoft.com/office/drawing/2014/main" id="{1872BA0E-760D-4FF9-8DE6-55715B58FDE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5" t="56344" r="18662" b="24965"/>
          <a:stretch/>
        </p:blipFill>
        <p:spPr>
          <a:xfrm>
            <a:off x="970379" y="4271189"/>
            <a:ext cx="2611239" cy="61214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9" name="그림 258" descr="벽, 기기, 실내, 하얀색이(가) 표시된 사진&#10;&#10;자동 생성된 설명">
            <a:extLst>
              <a:ext uri="{FF2B5EF4-FFF2-40B4-BE49-F238E27FC236}">
                <a16:creationId xmlns:a16="http://schemas.microsoft.com/office/drawing/2014/main" id="{C27400DD-6531-45F1-A7E1-D59882F5401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5" t="45931" r="16711" b="28970"/>
          <a:stretch/>
        </p:blipFill>
        <p:spPr>
          <a:xfrm>
            <a:off x="970379" y="4955824"/>
            <a:ext cx="2611239" cy="87034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1" name="그림 260">
            <a:extLst>
              <a:ext uri="{FF2B5EF4-FFF2-40B4-BE49-F238E27FC236}">
                <a16:creationId xmlns:a16="http://schemas.microsoft.com/office/drawing/2014/main" id="{D6CE6F95-EC05-4036-9532-DC903DEE57C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53" t="53398" r="23922" b="28579"/>
          <a:stretch/>
        </p:blipFill>
        <p:spPr>
          <a:xfrm>
            <a:off x="3947274" y="4275699"/>
            <a:ext cx="2593712" cy="6067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3" name="그림 262" descr="벽, 실내, 기기, 하얀색이(가) 표시된 사진&#10;&#10;자동 생성된 설명">
            <a:extLst>
              <a:ext uri="{FF2B5EF4-FFF2-40B4-BE49-F238E27FC236}">
                <a16:creationId xmlns:a16="http://schemas.microsoft.com/office/drawing/2014/main" id="{0A376A28-625B-4ADB-9DFF-E112675BDDB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70" t="45702" r="19080" b="28921"/>
          <a:stretch/>
        </p:blipFill>
        <p:spPr>
          <a:xfrm>
            <a:off x="3947305" y="4947999"/>
            <a:ext cx="2598488" cy="8799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6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667835" y="425538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3668549" y="5165678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3608693" y="4072710"/>
            <a:ext cx="436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4" name="직선 연결선 273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3911111" y="528878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TextBox 313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1722116" y="1494234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1958193" y="1494234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9F219E5F-E1CB-49C7-B0E3-ECC865CFAE69}"/>
              </a:ext>
            </a:extLst>
          </p:cNvPr>
          <p:cNvSpPr txBox="1"/>
          <p:nvPr/>
        </p:nvSpPr>
        <p:spPr>
          <a:xfrm>
            <a:off x="41652" y="96883"/>
            <a:ext cx="43681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692680" y="448013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937333" y="4605964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3669068" y="448013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3910997" y="460673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692680" y="538798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938920" y="551562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88">
            <a:extLst>
              <a:ext uri="{FF2B5EF4-FFF2-40B4-BE49-F238E27FC236}">
                <a16:creationId xmlns:a16="http://schemas.microsoft.com/office/drawing/2014/main" id="{41D0A329-23ED-4F17-8498-8021FDB427E3}"/>
              </a:ext>
            </a:extLst>
          </p:cNvPr>
          <p:cNvSpPr txBox="1"/>
          <p:nvPr/>
        </p:nvSpPr>
        <p:spPr>
          <a:xfrm>
            <a:off x="3666172" y="544801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3907344" y="557018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88">
            <a:extLst>
              <a:ext uri="{FF2B5EF4-FFF2-40B4-BE49-F238E27FC236}">
                <a16:creationId xmlns:a16="http://schemas.microsoft.com/office/drawing/2014/main" id="{FAAFA852-C263-4C3A-B618-F5A88E9573AF}"/>
              </a:ext>
            </a:extLst>
          </p:cNvPr>
          <p:cNvSpPr txBox="1"/>
          <p:nvPr/>
        </p:nvSpPr>
        <p:spPr>
          <a:xfrm>
            <a:off x="687936" y="227307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8388FA38-17AA-427D-8195-9B6CE6C0057A}"/>
              </a:ext>
            </a:extLst>
          </p:cNvPr>
          <p:cNvCxnSpPr>
            <a:cxnSpLocks/>
          </p:cNvCxnSpPr>
          <p:nvPr/>
        </p:nvCxnSpPr>
        <p:spPr>
          <a:xfrm>
            <a:off x="923374" y="2402465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88">
            <a:extLst>
              <a:ext uri="{FF2B5EF4-FFF2-40B4-BE49-F238E27FC236}">
                <a16:creationId xmlns:a16="http://schemas.microsoft.com/office/drawing/2014/main" id="{FAAFA852-C263-4C3A-B618-F5A88E9573AF}"/>
              </a:ext>
            </a:extLst>
          </p:cNvPr>
          <p:cNvSpPr txBox="1"/>
          <p:nvPr/>
        </p:nvSpPr>
        <p:spPr>
          <a:xfrm>
            <a:off x="3659123" y="227151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8388FA38-17AA-427D-8195-9B6CE6C0057A}"/>
              </a:ext>
            </a:extLst>
          </p:cNvPr>
          <p:cNvCxnSpPr>
            <a:cxnSpLocks/>
          </p:cNvCxnSpPr>
          <p:nvPr/>
        </p:nvCxnSpPr>
        <p:spPr>
          <a:xfrm>
            <a:off x="3899448" y="239706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660240" y="190137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897548" y="203196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그룹 3"/>
          <p:cNvGrpSpPr/>
          <p:nvPr/>
        </p:nvGrpSpPr>
        <p:grpSpPr>
          <a:xfrm>
            <a:off x="965070" y="1724507"/>
            <a:ext cx="2610000" cy="450000"/>
            <a:chOff x="2457450" y="4795162"/>
            <a:chExt cx="3028950" cy="782389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99" t="46220" r="28830" b="41022"/>
            <a:stretch/>
          </p:blipFill>
          <p:spPr>
            <a:xfrm>
              <a:off x="2457450" y="4800603"/>
              <a:ext cx="3028950" cy="77152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03" t="46130" r="65520" b="40934"/>
            <a:stretch/>
          </p:blipFill>
          <p:spPr>
            <a:xfrm>
              <a:off x="2457757" y="4795162"/>
              <a:ext cx="255299" cy="782389"/>
            </a:xfrm>
            <a:prstGeom prst="rect">
              <a:avLst/>
            </a:prstGeom>
          </p:spPr>
        </p:pic>
      </p:grpSp>
      <p:sp>
        <p:nvSpPr>
          <p:cNvPr id="149" name="TextBox 148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4162912" y="1441391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4355360" y="1362066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7998B0A6-8B81-4190-AF33-FDF0FCFBC8E1}"/>
              </a:ext>
            </a:extLst>
          </p:cNvPr>
          <p:cNvSpPr txBox="1"/>
          <p:nvPr/>
        </p:nvSpPr>
        <p:spPr>
          <a:xfrm>
            <a:off x="4222390" y="105848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4312505" y="1295334"/>
            <a:ext cx="446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4710609" y="1492433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4946686" y="1492433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2910411" y="1440779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3102859" y="1361454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2471032" y="1491821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2707109" y="1491821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210E6C5-6D1C-423A-B3EB-C4F637582700}"/>
              </a:ext>
            </a:extLst>
          </p:cNvPr>
          <p:cNvSpPr txBox="1"/>
          <p:nvPr/>
        </p:nvSpPr>
        <p:spPr>
          <a:xfrm>
            <a:off x="5937109" y="106499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E08010E2-12D6-4D21-B91B-61418FDCFF67}"/>
              </a:ext>
            </a:extLst>
          </p:cNvPr>
          <p:cNvCxnSpPr>
            <a:cxnSpLocks/>
          </p:cNvCxnSpPr>
          <p:nvPr/>
        </p:nvCxnSpPr>
        <p:spPr>
          <a:xfrm>
            <a:off x="6059992" y="1287780"/>
            <a:ext cx="480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5920901" y="1440214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6144171" y="1360889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5481522" y="1491256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5717599" y="1491256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1183249" y="3971676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1375697" y="3892351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18A67C46-6AFD-4122-B0C3-9A2C0A31E8C2}"/>
              </a:ext>
            </a:extLst>
          </p:cNvPr>
          <p:cNvSpPr txBox="1"/>
          <p:nvPr/>
        </p:nvSpPr>
        <p:spPr>
          <a:xfrm>
            <a:off x="2008653" y="3284467"/>
            <a:ext cx="7531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998B0A6-8B81-4190-AF33-FDF0FCFBC8E1}"/>
              </a:ext>
            </a:extLst>
          </p:cNvPr>
          <p:cNvSpPr txBox="1"/>
          <p:nvPr/>
        </p:nvSpPr>
        <p:spPr>
          <a:xfrm>
            <a:off x="1242727" y="3588765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1332842" y="3825619"/>
            <a:ext cx="446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D210E6C5-6D1C-423A-B3EB-C4F637582700}"/>
              </a:ext>
            </a:extLst>
          </p:cNvPr>
          <p:cNvSpPr txBox="1"/>
          <p:nvPr/>
        </p:nvSpPr>
        <p:spPr>
          <a:xfrm>
            <a:off x="2935449" y="359404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id="{E08010E2-12D6-4D21-B91B-61418FDCFF67}"/>
              </a:ext>
            </a:extLst>
          </p:cNvPr>
          <p:cNvCxnSpPr>
            <a:cxnSpLocks/>
          </p:cNvCxnSpPr>
          <p:nvPr/>
        </p:nvCxnSpPr>
        <p:spPr>
          <a:xfrm>
            <a:off x="3058332" y="3816829"/>
            <a:ext cx="480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F893D8FC-90EC-4047-83FC-62438E66FC16}"/>
              </a:ext>
            </a:extLst>
          </p:cNvPr>
          <p:cNvSpPr txBox="1"/>
          <p:nvPr/>
        </p:nvSpPr>
        <p:spPr>
          <a:xfrm>
            <a:off x="4825406" y="3283076"/>
            <a:ext cx="121217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1730946" y="4022718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1967023" y="4022718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4159996" y="3969875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4352444" y="3890550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7998B0A6-8B81-4190-AF33-FDF0FCFBC8E1}"/>
              </a:ext>
            </a:extLst>
          </p:cNvPr>
          <p:cNvSpPr txBox="1"/>
          <p:nvPr/>
        </p:nvSpPr>
        <p:spPr>
          <a:xfrm>
            <a:off x="4219474" y="3586964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5" name="직선 연결선 184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4309589" y="3823818"/>
            <a:ext cx="446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4707693" y="4020917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4943770" y="4020917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2950063" y="3969263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3169499" y="3889938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2500410" y="4020305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2746761" y="4020305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D210E6C5-6D1C-423A-B3EB-C4F637582700}"/>
              </a:ext>
            </a:extLst>
          </p:cNvPr>
          <p:cNvSpPr txBox="1"/>
          <p:nvPr/>
        </p:nvSpPr>
        <p:spPr>
          <a:xfrm>
            <a:off x="5934193" y="359347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-mont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" name="직선 연결선 192">
            <a:extLst>
              <a:ext uri="{FF2B5EF4-FFF2-40B4-BE49-F238E27FC236}">
                <a16:creationId xmlns:a16="http://schemas.microsoft.com/office/drawing/2014/main" id="{E08010E2-12D6-4D21-B91B-61418FDCFF67}"/>
              </a:ext>
            </a:extLst>
          </p:cNvPr>
          <p:cNvCxnSpPr>
            <a:cxnSpLocks/>
          </p:cNvCxnSpPr>
          <p:nvPr/>
        </p:nvCxnSpPr>
        <p:spPr>
          <a:xfrm>
            <a:off x="6057076" y="3816264"/>
            <a:ext cx="480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D81281BB-D218-4DFE-81D2-0D101E4BF67D}"/>
              </a:ext>
            </a:extLst>
          </p:cNvPr>
          <p:cNvSpPr txBox="1"/>
          <p:nvPr/>
        </p:nvSpPr>
        <p:spPr>
          <a:xfrm rot="18429552">
            <a:off x="5938533" y="3968698"/>
            <a:ext cx="4369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 rot="18429552">
            <a:off x="6151529" y="3889373"/>
            <a:ext cx="60743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az-Cyrl-AZ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х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5499154" y="4019740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DB3389C3-F1DD-44F0-A643-639E6DF35D43}"/>
              </a:ext>
            </a:extLst>
          </p:cNvPr>
          <p:cNvSpPr txBox="1"/>
          <p:nvPr/>
        </p:nvSpPr>
        <p:spPr>
          <a:xfrm>
            <a:off x="5735231" y="4019740"/>
            <a:ext cx="173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직선 연결선 197">
            <a:extLst>
              <a:ext uri="{FF2B5EF4-FFF2-40B4-BE49-F238E27FC236}">
                <a16:creationId xmlns:a16="http://schemas.microsoft.com/office/drawing/2014/main" id="{112B4638-4D74-41AE-BCB9-C2275F615556}"/>
              </a:ext>
            </a:extLst>
          </p:cNvPr>
          <p:cNvCxnSpPr>
            <a:cxnSpLocks/>
          </p:cNvCxnSpPr>
          <p:nvPr/>
        </p:nvCxnSpPr>
        <p:spPr>
          <a:xfrm>
            <a:off x="3911437" y="437923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735442" y="1840202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712248" y="1840324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738400" y="4413800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718800" y="4412655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D333AF-A187-F7B4-93E2-A6B15F1EFB01}"/>
              </a:ext>
            </a:extLst>
          </p:cNvPr>
          <p:cNvSpPr txBox="1"/>
          <p:nvPr/>
        </p:nvSpPr>
        <p:spPr>
          <a:xfrm>
            <a:off x="308945" y="6627941"/>
            <a:ext cx="716404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2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riginal western blot data for Figure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D. The asterisk (*) indicates the main signal band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479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24</TotalTime>
  <Words>125</Words>
  <Application>Microsoft Office PowerPoint</Application>
  <PresentationFormat>사용자 지정</PresentationFormat>
  <Paragraphs>7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JooJaeyeol</cp:lastModifiedBy>
  <cp:revision>760</cp:revision>
  <cp:lastPrinted>2020-05-22T07:46:34Z</cp:lastPrinted>
  <dcterms:created xsi:type="dcterms:W3CDTF">2017-05-04T04:46:32Z</dcterms:created>
  <dcterms:modified xsi:type="dcterms:W3CDTF">2022-11-11T22:45:32Z</dcterms:modified>
</cp:coreProperties>
</file>